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3" r:id="rId2"/>
  </p:sldIdLst>
  <p:sldSz cx="12192000" cy="6858000"/>
  <p:notesSz cx="6858000" cy="9144000"/>
  <p:defaultTextStyle>
    <a:defPPr>
      <a:defRPr lang="nl-B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D258EE2-BA9C-F327-F881-E90EB089EF2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l-NL"/>
              <a:t>Klik om stijl te bewerken</a:t>
            </a:r>
            <a:endParaRPr lang="nl-BE"/>
          </a:p>
        </p:txBody>
      </p:sp>
      <p:sp>
        <p:nvSpPr>
          <p:cNvPr id="3" name="Ondertitel 2">
            <a:extLst>
              <a:ext uri="{FF2B5EF4-FFF2-40B4-BE49-F238E27FC236}">
                <a16:creationId xmlns:a16="http://schemas.microsoft.com/office/drawing/2014/main" id="{CB668DEC-2C03-54D8-FA61-41AFAF56D3C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/>
              <a:t>Klikken om de ondertitelstijl van het model te bewerken</a:t>
            </a:r>
            <a:endParaRPr lang="nl-BE"/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F6250576-D98C-91AA-54E0-BDADDD11B3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2022F-0606-4292-BF8E-790DFD65816E}" type="datetimeFigureOut">
              <a:rPr lang="nl-BE" smtClean="0"/>
              <a:t>31/12/2024</a:t>
            </a:fld>
            <a:endParaRPr lang="nl-BE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4E01A111-65BA-0E3C-8A55-2286E14894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69A9455A-A11F-78D8-79D6-0D11347448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8F185B-C7EF-48EF-8BD8-252B786FEBD5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8709861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CF1DA11-4D8E-480B-3F45-228B1F26EA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nl-BE"/>
          </a:p>
        </p:txBody>
      </p:sp>
      <p:sp>
        <p:nvSpPr>
          <p:cNvPr id="3" name="Tijdelijke aanduiding voor verticale tekst 2">
            <a:extLst>
              <a:ext uri="{FF2B5EF4-FFF2-40B4-BE49-F238E27FC236}">
                <a16:creationId xmlns:a16="http://schemas.microsoft.com/office/drawing/2014/main" id="{210DA7CF-87A7-C21A-0B7D-1D58479FFFB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nl-BE"/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3341347A-861D-EE5C-738C-DFFEB6D8AB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2022F-0606-4292-BF8E-790DFD65816E}" type="datetimeFigureOut">
              <a:rPr lang="nl-BE" smtClean="0"/>
              <a:t>31/12/2024</a:t>
            </a:fld>
            <a:endParaRPr lang="nl-BE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7458CC11-A3F2-7ED2-D4E4-D410564156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0D127B9E-6858-6D0F-7F59-03338BD3F8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8F185B-C7EF-48EF-8BD8-252B786FEBD5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9515612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>
            <a:extLst>
              <a:ext uri="{FF2B5EF4-FFF2-40B4-BE49-F238E27FC236}">
                <a16:creationId xmlns:a16="http://schemas.microsoft.com/office/drawing/2014/main" id="{86E96D41-614B-ED2E-4659-52BD9C2EFB8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l-NL"/>
              <a:t>Klik om stijl te bewerken</a:t>
            </a:r>
            <a:endParaRPr lang="nl-BE"/>
          </a:p>
        </p:txBody>
      </p:sp>
      <p:sp>
        <p:nvSpPr>
          <p:cNvPr id="3" name="Tijdelijke aanduiding voor verticale tekst 2">
            <a:extLst>
              <a:ext uri="{FF2B5EF4-FFF2-40B4-BE49-F238E27FC236}">
                <a16:creationId xmlns:a16="http://schemas.microsoft.com/office/drawing/2014/main" id="{4A53531E-ADAA-0A72-382B-60D79D1BAED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nl-BE"/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C964D422-1C55-6473-5ADB-18CEC5A758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2022F-0606-4292-BF8E-790DFD65816E}" type="datetimeFigureOut">
              <a:rPr lang="nl-BE" smtClean="0"/>
              <a:t>31/12/2024</a:t>
            </a:fld>
            <a:endParaRPr lang="nl-BE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AAAB7102-ED4E-4191-E48D-F805DFEF8F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3C610997-A91D-F20B-2B06-9745C3DABA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8F185B-C7EF-48EF-8BD8-252B786FEBD5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71445420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40174622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660738C-8183-5736-76FC-8FF880DA1C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nl-BE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D48EF4A5-3AFD-3E69-77BA-98249A1A1B9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nl-BE"/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4A0982E2-A7FB-0417-AB62-B15F80ABDF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2022F-0606-4292-BF8E-790DFD65816E}" type="datetimeFigureOut">
              <a:rPr lang="nl-BE" smtClean="0"/>
              <a:t>31/12/2024</a:t>
            </a:fld>
            <a:endParaRPr lang="nl-BE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8CC82B79-D80D-A006-13E4-95D6BBF1A9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A7508215-41D3-4DB4-A60A-936E94E14E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8F185B-C7EF-48EF-8BD8-252B786FEBD5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926451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E031698-8DAB-91AA-9856-2ED7BD1701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l-NL"/>
              <a:t>Klik om stijl te bewerken</a:t>
            </a:r>
            <a:endParaRPr lang="nl-BE"/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F2A79FF9-5C73-A199-26C1-FF3B29D550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74CFF6F5-544D-0F07-FF13-D44F932E39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2022F-0606-4292-BF8E-790DFD65816E}" type="datetimeFigureOut">
              <a:rPr lang="nl-BE" smtClean="0"/>
              <a:t>31/12/2024</a:t>
            </a:fld>
            <a:endParaRPr lang="nl-BE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B6DFD511-D627-FECD-3950-0857118091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A9656CC1-A47E-F009-66DA-DF1EFC7625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8F185B-C7EF-48EF-8BD8-252B786FEBD5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5828244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16F3AEF-A487-28DF-C754-823E7CBDB4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nl-BE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0E2A8FB9-6431-D71C-8001-F4CCC1B1FE0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nl-BE"/>
          </a:p>
        </p:txBody>
      </p:sp>
      <p:sp>
        <p:nvSpPr>
          <p:cNvPr id="4" name="Tijdelijke aanduiding voor inhoud 3">
            <a:extLst>
              <a:ext uri="{FF2B5EF4-FFF2-40B4-BE49-F238E27FC236}">
                <a16:creationId xmlns:a16="http://schemas.microsoft.com/office/drawing/2014/main" id="{C4FD3090-B768-C084-5726-39DB509278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nl-BE"/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42D47313-8A7A-FD3D-81F9-C9618F493A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2022F-0606-4292-BF8E-790DFD65816E}" type="datetimeFigureOut">
              <a:rPr lang="nl-BE" smtClean="0"/>
              <a:t>31/12/2024</a:t>
            </a:fld>
            <a:endParaRPr lang="nl-BE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D65726B3-1C0B-54F9-0100-C5F00C7086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356D5F9B-E321-8028-82F5-92B8AB09E0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8F185B-C7EF-48EF-8BD8-252B786FEBD5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1985446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4A38CBB-5C77-BFE1-7A59-87EC329544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l-NL"/>
              <a:t>Klik om stijl te bewerken</a:t>
            </a:r>
            <a:endParaRPr lang="nl-BE"/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E63EDCB9-AD77-AEA3-F5E1-FBD38E49BD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Tijdelijke aanduiding voor inhoud 3">
            <a:extLst>
              <a:ext uri="{FF2B5EF4-FFF2-40B4-BE49-F238E27FC236}">
                <a16:creationId xmlns:a16="http://schemas.microsoft.com/office/drawing/2014/main" id="{00F44B7A-0918-955C-8BD7-2A92B0358B3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nl-BE"/>
          </a:p>
        </p:txBody>
      </p:sp>
      <p:sp>
        <p:nvSpPr>
          <p:cNvPr id="5" name="Tijdelijke aanduiding voor tekst 4">
            <a:extLst>
              <a:ext uri="{FF2B5EF4-FFF2-40B4-BE49-F238E27FC236}">
                <a16:creationId xmlns:a16="http://schemas.microsoft.com/office/drawing/2014/main" id="{059B9832-A338-82A5-01FD-E38021F308F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6" name="Tijdelijke aanduiding voor inhoud 5">
            <a:extLst>
              <a:ext uri="{FF2B5EF4-FFF2-40B4-BE49-F238E27FC236}">
                <a16:creationId xmlns:a16="http://schemas.microsoft.com/office/drawing/2014/main" id="{03360F96-F874-BECE-586E-A068D4DEABF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nl-BE"/>
          </a:p>
        </p:txBody>
      </p:sp>
      <p:sp>
        <p:nvSpPr>
          <p:cNvPr id="7" name="Tijdelijke aanduiding voor datum 6">
            <a:extLst>
              <a:ext uri="{FF2B5EF4-FFF2-40B4-BE49-F238E27FC236}">
                <a16:creationId xmlns:a16="http://schemas.microsoft.com/office/drawing/2014/main" id="{47C985A5-2310-CAB8-064B-BB347F1B47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2022F-0606-4292-BF8E-790DFD65816E}" type="datetimeFigureOut">
              <a:rPr lang="nl-BE" smtClean="0"/>
              <a:t>31/12/2024</a:t>
            </a:fld>
            <a:endParaRPr lang="nl-BE"/>
          </a:p>
        </p:txBody>
      </p:sp>
      <p:sp>
        <p:nvSpPr>
          <p:cNvPr id="8" name="Tijdelijke aanduiding voor voettekst 7">
            <a:extLst>
              <a:ext uri="{FF2B5EF4-FFF2-40B4-BE49-F238E27FC236}">
                <a16:creationId xmlns:a16="http://schemas.microsoft.com/office/drawing/2014/main" id="{E5CCA6D4-4A89-6606-EF05-E7DF868843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9" name="Tijdelijke aanduiding voor dianummer 8">
            <a:extLst>
              <a:ext uri="{FF2B5EF4-FFF2-40B4-BE49-F238E27FC236}">
                <a16:creationId xmlns:a16="http://schemas.microsoft.com/office/drawing/2014/main" id="{B24DC901-E69F-E5F1-D940-08BEF4ACEA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8F185B-C7EF-48EF-8BD8-252B786FEBD5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8908286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9CBD42A-AF91-0886-55D5-B94D325FD4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nl-BE"/>
          </a:p>
        </p:txBody>
      </p:sp>
      <p:sp>
        <p:nvSpPr>
          <p:cNvPr id="3" name="Tijdelijke aanduiding voor datum 2">
            <a:extLst>
              <a:ext uri="{FF2B5EF4-FFF2-40B4-BE49-F238E27FC236}">
                <a16:creationId xmlns:a16="http://schemas.microsoft.com/office/drawing/2014/main" id="{EDEA3D35-4E07-0261-D82F-AEBC2EC931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2022F-0606-4292-BF8E-790DFD65816E}" type="datetimeFigureOut">
              <a:rPr lang="nl-BE" smtClean="0"/>
              <a:t>31/12/2024</a:t>
            </a:fld>
            <a:endParaRPr lang="nl-BE"/>
          </a:p>
        </p:txBody>
      </p:sp>
      <p:sp>
        <p:nvSpPr>
          <p:cNvPr id="4" name="Tijdelijke aanduiding voor voettekst 3">
            <a:extLst>
              <a:ext uri="{FF2B5EF4-FFF2-40B4-BE49-F238E27FC236}">
                <a16:creationId xmlns:a16="http://schemas.microsoft.com/office/drawing/2014/main" id="{5FE2A5B1-54B2-A1C3-B227-E25D8060AE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5" name="Tijdelijke aanduiding voor dianummer 4">
            <a:extLst>
              <a:ext uri="{FF2B5EF4-FFF2-40B4-BE49-F238E27FC236}">
                <a16:creationId xmlns:a16="http://schemas.microsoft.com/office/drawing/2014/main" id="{2076602A-AA10-CA34-7111-A5D9F52941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8F185B-C7EF-48EF-8BD8-252B786FEBD5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42716293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>
            <a:extLst>
              <a:ext uri="{FF2B5EF4-FFF2-40B4-BE49-F238E27FC236}">
                <a16:creationId xmlns:a16="http://schemas.microsoft.com/office/drawing/2014/main" id="{096EA783-25FA-B967-7842-8B59FDC765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2022F-0606-4292-BF8E-790DFD65816E}" type="datetimeFigureOut">
              <a:rPr lang="nl-BE" smtClean="0"/>
              <a:t>31/12/2024</a:t>
            </a:fld>
            <a:endParaRPr lang="nl-BE"/>
          </a:p>
        </p:txBody>
      </p:sp>
      <p:sp>
        <p:nvSpPr>
          <p:cNvPr id="3" name="Tijdelijke aanduiding voor voettekst 2">
            <a:extLst>
              <a:ext uri="{FF2B5EF4-FFF2-40B4-BE49-F238E27FC236}">
                <a16:creationId xmlns:a16="http://schemas.microsoft.com/office/drawing/2014/main" id="{2808AF95-7B55-389D-D4F2-EBAAB47EB5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4" name="Tijdelijke aanduiding voor dianummer 3">
            <a:extLst>
              <a:ext uri="{FF2B5EF4-FFF2-40B4-BE49-F238E27FC236}">
                <a16:creationId xmlns:a16="http://schemas.microsoft.com/office/drawing/2014/main" id="{15D983C1-5398-49C1-8999-5AB257487C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8F185B-C7EF-48EF-8BD8-252B786FEBD5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40633460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0CBB529-7AD7-069F-4715-B39F67A937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stijl te bewerken</a:t>
            </a:r>
            <a:endParaRPr lang="nl-BE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FF3E1101-4AD4-971C-B5B5-A2678100ADC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nl-BE"/>
          </a:p>
        </p:txBody>
      </p:sp>
      <p:sp>
        <p:nvSpPr>
          <p:cNvPr id="4" name="Tijdelijke aanduiding voor tekst 3">
            <a:extLst>
              <a:ext uri="{FF2B5EF4-FFF2-40B4-BE49-F238E27FC236}">
                <a16:creationId xmlns:a16="http://schemas.microsoft.com/office/drawing/2014/main" id="{2523921F-C910-691E-DB2C-7367EBF9B1B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85AB38DD-9903-BA8C-8887-ECF35C016D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2022F-0606-4292-BF8E-790DFD65816E}" type="datetimeFigureOut">
              <a:rPr lang="nl-BE" smtClean="0"/>
              <a:t>31/12/2024</a:t>
            </a:fld>
            <a:endParaRPr lang="nl-BE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E801716E-F1DA-BE65-4ECB-D5B651123A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4DC5FC4F-B812-3110-8D06-D8171A217D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8F185B-C7EF-48EF-8BD8-252B786FEBD5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5847182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6E3BC6E-EFA9-F162-B6D3-D358C91C58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stijl te bewerken</a:t>
            </a:r>
            <a:endParaRPr lang="nl-BE"/>
          </a:p>
        </p:txBody>
      </p:sp>
      <p:sp>
        <p:nvSpPr>
          <p:cNvPr id="3" name="Tijdelijke aanduiding voor afbeelding 2">
            <a:extLst>
              <a:ext uri="{FF2B5EF4-FFF2-40B4-BE49-F238E27FC236}">
                <a16:creationId xmlns:a16="http://schemas.microsoft.com/office/drawing/2014/main" id="{7ABC591D-5596-7F82-E3AA-299FDC7C3E2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BE"/>
          </a:p>
        </p:txBody>
      </p:sp>
      <p:sp>
        <p:nvSpPr>
          <p:cNvPr id="4" name="Tijdelijke aanduiding voor tekst 3">
            <a:extLst>
              <a:ext uri="{FF2B5EF4-FFF2-40B4-BE49-F238E27FC236}">
                <a16:creationId xmlns:a16="http://schemas.microsoft.com/office/drawing/2014/main" id="{84AEF3B1-74CA-6FC3-C523-88FCA153F2E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FC2B7AB2-E245-D4C0-DDF8-151D1EED1F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2022F-0606-4292-BF8E-790DFD65816E}" type="datetimeFigureOut">
              <a:rPr lang="nl-BE" smtClean="0"/>
              <a:t>31/12/2024</a:t>
            </a:fld>
            <a:endParaRPr lang="nl-BE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E2A65E13-6016-2DC7-9103-A3A707A22F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BCCF4280-1123-6937-BEC4-B719014439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8F185B-C7EF-48EF-8BD8-252B786FEBD5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8775823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>
            <a:extLst>
              <a:ext uri="{FF2B5EF4-FFF2-40B4-BE49-F238E27FC236}">
                <a16:creationId xmlns:a16="http://schemas.microsoft.com/office/drawing/2014/main" id="{A29CBFF3-9D62-2AC1-5ED0-265CDF8BA0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stijl te bewerken</a:t>
            </a:r>
            <a:endParaRPr lang="nl-BE"/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32583BB7-466C-0FD3-DB53-5D2962EAE8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nl-BE"/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8234D41B-4D8A-E5C7-0D65-4081F2CBEE6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32022F-0606-4292-BF8E-790DFD65816E}" type="datetimeFigureOut">
              <a:rPr lang="nl-BE" smtClean="0"/>
              <a:t>31/12/2024</a:t>
            </a:fld>
            <a:endParaRPr lang="nl-BE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C7C1541B-F0B3-E5E1-0A85-7C2A889FA0E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BE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0E33C4F3-814A-FC0F-B23F-D4C7CA7D294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8F185B-C7EF-48EF-8BD8-252B786FEBD5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3151266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B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948A3A-29D4-44D6-0EB0-CE2B69BB640B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Individualized transitional care in childhood-onset systemic lupus erythematosus (SLE) and lupus nephritis (LN): a proposed framework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98172A3-B575-316A-64DF-267B75C4D920}"/>
              </a:ext>
            </a:extLst>
          </p:cNvPr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Renson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F681059-5890-5822-ECFE-A91B61BC57D3}"/>
              </a:ext>
            </a:extLst>
          </p:cNvPr>
          <p:cNvSpPr txBox="1"/>
          <p:nvPr/>
        </p:nvSpPr>
        <p:spPr>
          <a:xfrm>
            <a:off x="173448" y="571917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TAKE HOME MESSAGE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Evidence-based, structured and flexible transitional care protocols, tailored to the unique needs of the individual patient, are required to optimize long-term outcomes in SLE and LN.</a:t>
            </a:r>
            <a:endParaRPr lang="nl-BE" dirty="0">
              <a:solidFill>
                <a:schemeClr val="bg1"/>
              </a:solidFill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CCBD21B-2D76-A9F5-ECF6-56BF9ABDA480}"/>
              </a:ext>
            </a:extLst>
          </p:cNvPr>
          <p:cNvSpPr txBox="1"/>
          <p:nvPr/>
        </p:nvSpPr>
        <p:spPr>
          <a:xfrm>
            <a:off x="250370" y="1258206"/>
            <a:ext cx="11663463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3969"/>
                </a:solidFill>
              </a:rPr>
              <a:t>Key points</a:t>
            </a:r>
            <a:r>
              <a:rPr lang="en-GB" dirty="0">
                <a:solidFill>
                  <a:srgbClr val="003969"/>
                </a:solidFill>
              </a:rPr>
              <a:t>: </a:t>
            </a:r>
          </a:p>
          <a:p>
            <a:endParaRPr lang="en-GB" dirty="0">
              <a:solidFill>
                <a:srgbClr val="003969"/>
              </a:solidFill>
            </a:endParaRPr>
          </a:p>
          <a:p>
            <a:r>
              <a:rPr lang="en-GB" dirty="0">
                <a:solidFill>
                  <a:srgbClr val="003969"/>
                </a:solidFill>
              </a:rPr>
              <a:t>1. Adolescents and young adults with SLE and LN face many disease-specific and psychosocial challenges. </a:t>
            </a:r>
          </a:p>
          <a:p>
            <a:endParaRPr lang="en-GB" dirty="0">
              <a:solidFill>
                <a:srgbClr val="003969"/>
              </a:solidFill>
            </a:endParaRPr>
          </a:p>
          <a:p>
            <a:r>
              <a:rPr lang="en-GB" dirty="0">
                <a:solidFill>
                  <a:srgbClr val="003969"/>
                </a:solidFill>
              </a:rPr>
              <a:t>2. These challenges hamper an optimal transition to adult health care systems. </a:t>
            </a:r>
          </a:p>
          <a:p>
            <a:endParaRPr lang="en-GB" dirty="0">
              <a:solidFill>
                <a:srgbClr val="003969"/>
              </a:solidFill>
            </a:endParaRPr>
          </a:p>
          <a:p>
            <a:r>
              <a:rPr lang="en-GB" dirty="0">
                <a:solidFill>
                  <a:srgbClr val="003969"/>
                </a:solidFill>
              </a:rPr>
              <a:t>3. There is a huge cultural and structural gap between pediatric and adult health care. </a:t>
            </a:r>
          </a:p>
          <a:p>
            <a:endParaRPr lang="en-GB" dirty="0">
              <a:solidFill>
                <a:srgbClr val="003969"/>
              </a:solidFill>
            </a:endParaRPr>
          </a:p>
          <a:p>
            <a:r>
              <a:rPr lang="en-GB" dirty="0">
                <a:solidFill>
                  <a:srgbClr val="003969"/>
                </a:solidFill>
              </a:rPr>
              <a:t>4. Current transitional care programs are heterogeneous, suboptimal, or even non-existent. </a:t>
            </a:r>
          </a:p>
          <a:p>
            <a:endParaRPr lang="en-GB" dirty="0">
              <a:solidFill>
                <a:srgbClr val="003969"/>
              </a:solidFill>
            </a:endParaRPr>
          </a:p>
          <a:p>
            <a:r>
              <a:rPr lang="en-GB" dirty="0">
                <a:solidFill>
                  <a:srgbClr val="003969"/>
                </a:solidFill>
              </a:rPr>
              <a:t>5. Transitional care protocols are needed and should adopt a multi- and interdisciplinary approach, and address timing of transfer, transition readiness of the patient, the importance of peer support, and optimization of treatment adherence. </a:t>
            </a:r>
          </a:p>
        </p:txBody>
      </p:sp>
    </p:spTree>
    <p:extLst>
      <p:ext uri="{BB962C8B-B14F-4D97-AF65-F5344CB8AC3E}">
        <p14:creationId xmlns:p14="http://schemas.microsoft.com/office/powerpoint/2010/main" val="2977807225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165</Words>
  <Application>Microsoft Office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Kantoorthema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Renson Thomas</dc:creator>
  <cp:lastModifiedBy>Bob Thompson</cp:lastModifiedBy>
  <cp:revision>5</cp:revision>
  <dcterms:created xsi:type="dcterms:W3CDTF">2024-12-17T14:47:24Z</dcterms:created>
  <dcterms:modified xsi:type="dcterms:W3CDTF">2024-12-31T21:03:58Z</dcterms:modified>
</cp:coreProperties>
</file>